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6" autoAdjust="0"/>
    <p:restoredTop sz="94660"/>
  </p:normalViewPr>
  <p:slideViewPr>
    <p:cSldViewPr snapToGrid="0">
      <p:cViewPr varScale="1">
        <p:scale>
          <a:sx n="69" d="100"/>
          <a:sy n="69" d="100"/>
        </p:scale>
        <p:origin x="96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FDE34A-6695-425A-BE1E-F10DC0052BE1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211C2-1F59-4BE1-9BE5-2F4430372E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8757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LC-MS/MS comparison of Fraction 7 and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uA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2-OH-HA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D211C2-1F59-4BE1-9BE5-2F4430372E2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5748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Partial purification of Aryl-LAs in the CSs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D211C2-1F59-4BE1-9BE5-2F4430372E27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2111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Chiral chromatography of Aryl-LAs</a:t>
            </a:r>
            <a:endParaRPr lang="ja-JP" altLang="ja-JP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D211C2-1F59-4BE1-9BE5-2F4430372E27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5803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61B315-398E-4040-AA2D-8E2F9A7DD9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893B92E-6160-4E43-A4EA-CFC9983F8C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BEAD95-D729-4785-AC4D-49AB65012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308A55-7B9A-4847-AF5D-FED306326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023DB7-D807-4185-BFCC-B4AB16C2D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85868-D468-4614-8AAD-C2290B1E6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86D8B75-A5E9-4506-8D5D-3A50FA94D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2C81BE-D116-4F5F-897B-91F3527D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309AC8-32A2-44B2-8200-B6BFFF7AB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B3B641-9175-46F9-9714-11FB24279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288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F4CCAD1-C299-41C4-861D-1C2653F867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880D59F-6A06-4C59-B24C-644639841A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20FFE9-D20C-4791-887A-8ACB3835C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211C6C-31C3-45C2-99F2-9B5694A70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8ED9ED-7F57-4CAE-8C90-D5EFBE230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4820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5077C1-B5E6-419E-8C82-E8A697964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9255F6-E0FF-4028-B9D6-DCE677BE4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7614B5-FAC1-4C8D-8708-D58E3E8E6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B61246-ED31-4F7B-AAA0-583367EB5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D40192-944F-4C44-8FF0-B617184B2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695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C7DECE-8672-4F7C-B707-CFBF4A58D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1A43D47-FD7A-4CAE-B815-479C938435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2F9B75-0290-4C05-B435-6C182195E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074FC3-8C40-4FB0-81EE-FA90ABBC3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7C69F5-AE89-426C-B616-8938FAFC4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724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D12F6E-8B75-459C-9EA5-4A87539070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160B9D-FBA7-4F67-A86E-7AD5C42295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4BEF72-440D-4E6F-A4FD-781886E446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4D6E45-506D-4032-AFE4-1E16A887A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C58EA6-9CF8-469E-9B95-2211EE8FF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08BA0F-E298-41EA-92CD-461F2F94E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4789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C9823F-0E32-4F2E-9D28-8DE2204EFE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4B87DD-789A-458B-8BB5-C851394BCE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16DB68-3D11-44D5-AD10-4AB393C6C6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580FC48-F141-403F-81A2-A1A21860A9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685083E-1D96-43E3-BE29-8BDB190068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E2B0D97-7D8B-46AF-AC73-0306FF50C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F3FD348-B19B-4816-A12E-0C5A41A60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9610B8E-2E48-497A-B790-F7F288932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399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291156-E7AC-484A-9E62-8B901E8502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353263-8F04-4426-A4B0-DAF7E5BC0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BDBE413-219B-4B5B-927E-881C8773B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B609107-F3D1-4BF3-9876-263756C17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345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00FE5F8-8660-4F18-BE55-9BE5A51F0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F42AD3A-8729-485E-8E31-E887A06EF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3CD2CFA-EEA1-49CC-9A0A-1E633DDFF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060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32E86C-E782-4CC7-A768-C0C6773B6E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07F731-3C67-4267-8A02-DB129DB329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757BD94-8E50-4625-B188-5FD977DB26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81FB25B-8B23-48E2-BF4C-2B0AF9425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C98752-6569-4870-99F5-845DB6689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AB8241-4C84-46F1-AA9F-53E6B0949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053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31B632-04FC-410C-A86D-4A6EDA8CDD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AE84067-EE0A-461C-8860-FE73738D97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02C2451-0FC0-45A1-AAAB-155C36146E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7A9578-7545-4119-90DD-9D2AE2FEE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0F5831-306D-419E-BE13-8C88DC69B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CC0D427-D7BC-4D5B-88BB-9C2A6034E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434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4C43FA1-0C71-4A74-9942-4AA1DF847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5B452AD-E923-4812-A44D-CFDE973690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FB5C00-C306-4D0F-B82E-3A0C92E912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87BF5-7F0B-411C-9EB5-5102284C11CC}" type="datetimeFigureOut">
              <a:rPr kumimoji="1" lang="ja-JP" altLang="en-US" smtClean="0"/>
              <a:t>2021/11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B20494-169E-4196-941D-60DD0F0F42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4A4B97-5006-4615-B527-1C50FADE60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D6763-036C-4BC7-8A1D-E365BAA75B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218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B596C97-215E-494F-9819-4E451EF74A18}"/>
              </a:ext>
            </a:extLst>
          </p:cNvPr>
          <p:cNvGrpSpPr/>
          <p:nvPr/>
        </p:nvGrpSpPr>
        <p:grpSpPr>
          <a:xfrm>
            <a:off x="535356" y="535321"/>
            <a:ext cx="11169158" cy="5788818"/>
            <a:chOff x="535356" y="535321"/>
            <a:chExt cx="11169158" cy="578881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35356" y="535321"/>
              <a:ext cx="5587559" cy="574516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386123" y="535321"/>
              <a:ext cx="5318391" cy="5788818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084035" y="713921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A-1</a:t>
              </a: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F7FD54FC-EC40-4984-92B1-3B9B987FEB6A}"/>
                </a:ext>
              </a:extLst>
            </p:cNvPr>
            <p:cNvSpPr txBox="1"/>
            <p:nvPr/>
          </p:nvSpPr>
          <p:spPr>
            <a:xfrm>
              <a:off x="1084035" y="2467253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A-2</a:t>
              </a:r>
            </a:p>
          </p:txBody>
        </p:sp>
        <p:sp>
          <p:nvSpPr>
            <p:cNvPr id="11" name="TextBox 6">
              <a:extLst>
                <a:ext uri="{FF2B5EF4-FFF2-40B4-BE49-F238E27FC236}">
                  <a16:creationId xmlns:a16="http://schemas.microsoft.com/office/drawing/2014/main" id="{AF9CD1E3-B711-4E52-A7D1-4A42E8EDE32A}"/>
                </a:ext>
              </a:extLst>
            </p:cNvPr>
            <p:cNvSpPr txBox="1"/>
            <p:nvPr/>
          </p:nvSpPr>
          <p:spPr>
            <a:xfrm>
              <a:off x="1084035" y="4220586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A-3</a:t>
              </a:r>
            </a:p>
          </p:txBody>
        </p:sp>
        <p:sp>
          <p:nvSpPr>
            <p:cNvPr id="12" name="TextBox 6">
              <a:extLst>
                <a:ext uri="{FF2B5EF4-FFF2-40B4-BE49-F238E27FC236}">
                  <a16:creationId xmlns:a16="http://schemas.microsoft.com/office/drawing/2014/main" id="{53404258-B250-4AE3-8390-2A5D7E504EAE}"/>
                </a:ext>
              </a:extLst>
            </p:cNvPr>
            <p:cNvSpPr txBox="1"/>
            <p:nvPr/>
          </p:nvSpPr>
          <p:spPr>
            <a:xfrm>
              <a:off x="6926035" y="713921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B-1</a:t>
              </a:r>
            </a:p>
          </p:txBody>
        </p:sp>
        <p:sp>
          <p:nvSpPr>
            <p:cNvPr id="13" name="TextBox 6">
              <a:extLst>
                <a:ext uri="{FF2B5EF4-FFF2-40B4-BE49-F238E27FC236}">
                  <a16:creationId xmlns:a16="http://schemas.microsoft.com/office/drawing/2014/main" id="{38D774EB-0F61-4FB5-A71F-30A92A6CBBED}"/>
                </a:ext>
              </a:extLst>
            </p:cNvPr>
            <p:cNvSpPr txBox="1"/>
            <p:nvPr/>
          </p:nvSpPr>
          <p:spPr>
            <a:xfrm>
              <a:off x="6926035" y="2467253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B-2</a:t>
              </a:r>
            </a:p>
          </p:txBody>
        </p:sp>
        <p:sp>
          <p:nvSpPr>
            <p:cNvPr id="14" name="TextBox 6">
              <a:extLst>
                <a:ext uri="{FF2B5EF4-FFF2-40B4-BE49-F238E27FC236}">
                  <a16:creationId xmlns:a16="http://schemas.microsoft.com/office/drawing/2014/main" id="{093FB136-6D38-413A-B9BB-83FCFC460A94}"/>
                </a:ext>
              </a:extLst>
            </p:cNvPr>
            <p:cNvSpPr txBox="1"/>
            <p:nvPr/>
          </p:nvSpPr>
          <p:spPr>
            <a:xfrm>
              <a:off x="6926035" y="4220586"/>
              <a:ext cx="5918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 Narrow" panose="020B0606020202030204" pitchFamily="34" charset="0"/>
                </a:rPr>
                <a:t>B-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735174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271D667-D2A8-4189-B6D3-98D4390C5B5F}"/>
              </a:ext>
            </a:extLst>
          </p:cNvPr>
          <p:cNvGrpSpPr/>
          <p:nvPr/>
        </p:nvGrpSpPr>
        <p:grpSpPr>
          <a:xfrm>
            <a:off x="0" y="492049"/>
            <a:ext cx="12192000" cy="5745302"/>
            <a:chOff x="0" y="492049"/>
            <a:chExt cx="12192000" cy="5745302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3"/>
            <a:stretch>
              <a:fillRect/>
            </a:stretch>
          </p:blipFill>
          <p:spPr>
            <a:xfrm>
              <a:off x="0" y="3589227"/>
              <a:ext cx="12192000" cy="2648124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4"/>
            <a:stretch>
              <a:fillRect/>
            </a:stretch>
          </p:blipFill>
          <p:spPr>
            <a:xfrm>
              <a:off x="0" y="492049"/>
              <a:ext cx="12192000" cy="2648124"/>
            </a:xfrm>
            <a:prstGeom prst="rect">
              <a:avLst/>
            </a:prstGeom>
          </p:spPr>
        </p:pic>
        <p:cxnSp>
          <p:nvCxnSpPr>
            <p:cNvPr id="3" name="直線矢印コネクタ 2">
              <a:extLst>
                <a:ext uri="{FF2B5EF4-FFF2-40B4-BE49-F238E27FC236}">
                  <a16:creationId xmlns:a16="http://schemas.microsoft.com/office/drawing/2014/main" id="{D0C84C40-8ADF-46DC-886F-DA01892BFDC9}"/>
                </a:ext>
              </a:extLst>
            </p:cNvPr>
            <p:cNvCxnSpPr>
              <a:cxnSpLocks/>
            </p:cNvCxnSpPr>
            <p:nvPr/>
          </p:nvCxnSpPr>
          <p:spPr>
            <a:xfrm>
              <a:off x="2981148" y="3347782"/>
              <a:ext cx="9180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648F9957-56FF-4C6C-926B-8CD541F3EF32}"/>
                </a:ext>
              </a:extLst>
            </p:cNvPr>
            <p:cNvCxnSpPr>
              <a:cxnSpLocks/>
            </p:cNvCxnSpPr>
            <p:nvPr/>
          </p:nvCxnSpPr>
          <p:spPr>
            <a:xfrm>
              <a:off x="5705926" y="3347782"/>
              <a:ext cx="7200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38C7CB59-040E-45F3-9DB0-D0376C10C710}"/>
                </a:ext>
              </a:extLst>
            </p:cNvPr>
            <p:cNvCxnSpPr>
              <a:cxnSpLocks/>
            </p:cNvCxnSpPr>
            <p:nvPr/>
          </p:nvCxnSpPr>
          <p:spPr>
            <a:xfrm>
              <a:off x="6586963" y="3347782"/>
              <a:ext cx="7200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E1EE162-7515-4633-A014-26B1B0C851CA}"/>
                </a:ext>
              </a:extLst>
            </p:cNvPr>
            <p:cNvSpPr txBox="1"/>
            <p:nvPr/>
          </p:nvSpPr>
          <p:spPr>
            <a:xfrm>
              <a:off x="1902062" y="859182"/>
              <a:ext cx="13676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4-OH-PLA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CA807F2-F7FF-4418-AB80-25BA973EF89A}"/>
                </a:ext>
              </a:extLst>
            </p:cNvPr>
            <p:cNvSpPr txBox="1"/>
            <p:nvPr/>
          </p:nvSpPr>
          <p:spPr>
            <a:xfrm>
              <a:off x="5171805" y="859182"/>
              <a:ext cx="6703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</a:t>
              </a:r>
              <a:endParaRPr kumimoji="1" lang="ja-JP" altLang="en-US" sz="2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A3BD0A7-6DFC-4302-A642-BA0FA1D1EF82}"/>
                </a:ext>
              </a:extLst>
            </p:cNvPr>
            <p:cNvSpPr txBox="1"/>
            <p:nvPr/>
          </p:nvSpPr>
          <p:spPr>
            <a:xfrm>
              <a:off x="6939553" y="859182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LA</a:t>
              </a:r>
              <a:endParaRPr kumimoji="1" lang="ja-JP" altLang="en-US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C823CD3-3C31-4514-BE56-E61A4394C647}"/>
                </a:ext>
              </a:extLst>
            </p:cNvPr>
            <p:cNvSpPr txBox="1"/>
            <p:nvPr/>
          </p:nvSpPr>
          <p:spPr>
            <a:xfrm>
              <a:off x="1109054" y="3163116"/>
              <a:ext cx="186781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Collecting time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9F3895A1-1953-40AF-9926-C06D6EA54FFD}"/>
                </a:ext>
              </a:extLst>
            </p:cNvPr>
            <p:cNvSpPr txBox="1"/>
            <p:nvPr/>
          </p:nvSpPr>
          <p:spPr>
            <a:xfrm>
              <a:off x="8432800" y="3708400"/>
              <a:ext cx="31470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lution pattern of typical CSs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E911200-C64E-4A6F-8E5C-6914CB478D52}"/>
                </a:ext>
              </a:extLst>
            </p:cNvPr>
            <p:cNvSpPr txBox="1"/>
            <p:nvPr/>
          </p:nvSpPr>
          <p:spPr>
            <a:xfrm>
              <a:off x="7881366" y="620649"/>
              <a:ext cx="35318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Elution pattern of standard </a:t>
              </a:r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LAs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493351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="" xmlns:c="http://schemas.openxmlformats.org/drawingml/2006/chart" xmlns:dgm="http://schemas.openxmlformats.org/drawingml/2006/diagram" xmlns:dsp="http://schemas.microsoft.com/office/drawing/2008/diagram">
      <p:transition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2FD217D2-371E-4DFB-A010-D44B96AF40B5}"/>
              </a:ext>
            </a:extLst>
          </p:cNvPr>
          <p:cNvGrpSpPr/>
          <p:nvPr/>
        </p:nvGrpSpPr>
        <p:grpSpPr>
          <a:xfrm>
            <a:off x="4110499" y="1235374"/>
            <a:ext cx="4185898" cy="4077118"/>
            <a:chOff x="4110499" y="1235374"/>
            <a:chExt cx="4185898" cy="4077118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52E40105-16FB-45BB-90E7-DC2AA1F57CA1}"/>
                </a:ext>
              </a:extLst>
            </p:cNvPr>
            <p:cNvGrpSpPr/>
            <p:nvPr/>
          </p:nvGrpSpPr>
          <p:grpSpPr>
            <a:xfrm>
              <a:off x="4110499" y="1235374"/>
              <a:ext cx="3971003" cy="4077118"/>
              <a:chOff x="3978043" y="1235374"/>
              <a:chExt cx="3971003" cy="4077118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663046" y="1983923"/>
                <a:ext cx="2286000" cy="3328569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3978043" y="2161718"/>
                <a:ext cx="12570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 Narrow" panose="020B0606020202030204" pitchFamily="34" charset="0"/>
                  </a:rPr>
                  <a:t>A: </a:t>
                </a:r>
                <a:r>
                  <a:rPr lang="en-US" b="1" dirty="0" err="1">
                    <a:latin typeface="Arial Narrow" panose="020B0606020202030204" pitchFamily="34" charset="0"/>
                  </a:rPr>
                  <a:t>Standerd</a:t>
                </a:r>
                <a:endParaRPr lang="en-US" sz="14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978043" y="2956375"/>
                <a:ext cx="7296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 Narrow" panose="020B0606020202030204" pitchFamily="34" charset="0"/>
                  </a:rPr>
                  <a:t>B: WT</a:t>
                </a:r>
                <a:endParaRPr lang="en-US" sz="14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978043" y="3751032"/>
                <a:ext cx="102463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 Narrow" panose="020B0606020202030204" pitchFamily="34" charset="0"/>
                  </a:rPr>
                  <a:t>C: </a:t>
                </a:r>
                <a:r>
                  <a:rPr lang="en-US" altLang="ja-JP" b="1" dirty="0">
                    <a:latin typeface="Arial Narrow" panose="020B0606020202030204" pitchFamily="34" charset="0"/>
                  </a:rPr>
                  <a:t>Δ</a:t>
                </a:r>
                <a:r>
                  <a:rPr lang="en-US" b="1" i="1" dirty="0">
                    <a:latin typeface="Arial Narrow" panose="020B0606020202030204" pitchFamily="34" charset="0"/>
                  </a:rPr>
                  <a:t>ldh</a:t>
                </a:r>
                <a:r>
                  <a:rPr lang="en-US" b="1" dirty="0">
                    <a:latin typeface="Arial Narrow" panose="020B0606020202030204" pitchFamily="34" charset="0"/>
                  </a:rPr>
                  <a:t>4</a:t>
                </a:r>
                <a:endParaRPr lang="en-US" sz="14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978043" y="4545690"/>
                <a:ext cx="11432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 Narrow" panose="020B0606020202030204" pitchFamily="34" charset="0"/>
                  </a:rPr>
                  <a:t>D: </a:t>
                </a:r>
                <a:r>
                  <a:rPr lang="en-US" altLang="ja-JP" b="1" dirty="0">
                    <a:latin typeface="Arial Narrow" panose="020B0606020202030204" pitchFamily="34" charset="0"/>
                  </a:rPr>
                  <a:t>Δ</a:t>
                </a:r>
                <a:r>
                  <a:rPr lang="en-US" b="1" i="1" dirty="0">
                    <a:latin typeface="Arial Narrow" panose="020B0606020202030204" pitchFamily="34" charset="0"/>
                  </a:rPr>
                  <a:t>d2hd</a:t>
                </a:r>
                <a:endParaRPr lang="en-US" sz="1400" b="1" i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141441" y="1235374"/>
                <a:ext cx="132921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2800" b="1" dirty="0">
                    <a:latin typeface="Arial Narrow" panose="020B0606020202030204" pitchFamily="34" charset="0"/>
                  </a:rPr>
                  <a:t>D-/L-</a:t>
                </a:r>
                <a:r>
                  <a:rPr lang="en-US" sz="2800" b="1" dirty="0">
                    <a:latin typeface="Arial Narrow" panose="020B0606020202030204" pitchFamily="34" charset="0"/>
                  </a:rPr>
                  <a:t>ILA</a:t>
                </a:r>
              </a:p>
            </p:txBody>
          </p:sp>
        </p:grp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85D6244-2CEE-4E55-BB4B-3E4437C48CF2}"/>
                </a:ext>
              </a:extLst>
            </p:cNvPr>
            <p:cNvSpPr txBox="1"/>
            <p:nvPr/>
          </p:nvSpPr>
          <p:spPr>
            <a:xfrm>
              <a:off x="6135718" y="2956375"/>
              <a:ext cx="4732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2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8779158-63B9-4533-BB88-3E653AC34192}"/>
                </a:ext>
              </a:extLst>
            </p:cNvPr>
            <p:cNvSpPr txBox="1"/>
            <p:nvPr/>
          </p:nvSpPr>
          <p:spPr>
            <a:xfrm>
              <a:off x="7730216" y="2956375"/>
              <a:ext cx="5661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98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CB2C95D2-A675-4E6E-915A-7DAB363CF9F4}"/>
                </a:ext>
              </a:extLst>
            </p:cNvPr>
            <p:cNvSpPr txBox="1"/>
            <p:nvPr/>
          </p:nvSpPr>
          <p:spPr>
            <a:xfrm>
              <a:off x="6135718" y="3687895"/>
              <a:ext cx="5661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98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4A969BE-796B-4E8B-845B-7FCF3BBD9949}"/>
                </a:ext>
              </a:extLst>
            </p:cNvPr>
            <p:cNvSpPr txBox="1"/>
            <p:nvPr/>
          </p:nvSpPr>
          <p:spPr>
            <a:xfrm>
              <a:off x="7730216" y="3687895"/>
              <a:ext cx="4732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2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98FCA07-80C8-4679-A511-1802C3047A6E}"/>
                </a:ext>
              </a:extLst>
            </p:cNvPr>
            <p:cNvSpPr txBox="1"/>
            <p:nvPr/>
          </p:nvSpPr>
          <p:spPr>
            <a:xfrm>
              <a:off x="6135718" y="4414884"/>
              <a:ext cx="4732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1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65ECF06-0214-498A-A67C-2B42C3E0CFEB}"/>
                </a:ext>
              </a:extLst>
            </p:cNvPr>
            <p:cNvSpPr txBox="1"/>
            <p:nvPr/>
          </p:nvSpPr>
          <p:spPr>
            <a:xfrm>
              <a:off x="7730216" y="4414884"/>
              <a:ext cx="5661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 Narrow" panose="020B0606020202030204" pitchFamily="34" charset="0"/>
                </a:rPr>
                <a:t>99 %</a:t>
              </a:r>
              <a:endParaRPr kumimoji="1" lang="ja-JP" altLang="en-US" sz="1600" b="1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94574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ワイド画面</PresentationFormat>
  <Paragraphs>29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Arial Narrow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21-08-08T04:55:23Z</dcterms:created>
  <dcterms:modified xsi:type="dcterms:W3CDTF">2021-11-20T23:54:59Z</dcterms:modified>
</cp:coreProperties>
</file>